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6" r:id="rId2"/>
    <p:sldId id="257" r:id="rId3"/>
  </p:sldIdLst>
  <p:sldSz cx="6858000" cy="9144000" type="screen4x3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8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09376E-A596-4F0E-AD69-F2332E292FB2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5B683A-6329-4332-86BF-C2E75A846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5957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019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88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445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940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928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891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386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376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746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941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50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764C4-6A9D-4659-9041-617783A32E6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C9C6F-62A8-40FC-8C52-74E222FFC1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181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openxmlformats.org/officeDocument/2006/relationships/image" Target="../media/image2.png"/><Relationship Id="rId15" Type="http://schemas.openxmlformats.org/officeDocument/2006/relationships/image" Target="../media/image12.png"/><Relationship Id="rId10" Type="http://schemas.openxmlformats.org/officeDocument/2006/relationships/image" Target="../media/image7.png"/><Relationship Id="rId4" Type="http://schemas.openxmlformats.org/officeDocument/2006/relationships/image" Target="../media/image1.emf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oleObject" Target="../embeddings/oleObject2.bin"/><Relationship Id="rId7" Type="http://schemas.openxmlformats.org/officeDocument/2006/relationships/image" Target="../media/image16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8855905"/>
            <a:ext cx="4443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1.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434710" y="556609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5045926"/>
              </p:ext>
            </p:extLst>
          </p:nvPr>
        </p:nvGraphicFramePr>
        <p:xfrm>
          <a:off x="3531101" y="6179934"/>
          <a:ext cx="2444484" cy="1390650"/>
        </p:xfrm>
        <a:graphic>
          <a:graphicData uri="http://schemas.openxmlformats.org/drawingml/2006/table">
            <a:tbl>
              <a:tblPr/>
              <a:tblGrid>
                <a:gridCol w="1846803"/>
                <a:gridCol w="597681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21</a:t>
                      </a:r>
                    </a:p>
                    <a:p>
                      <a:pPr algn="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 0.99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 (two-taile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 0.0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 the correlation significant? (alpha=0.05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 squar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43" name="Objec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4752447"/>
              </p:ext>
            </p:extLst>
          </p:nvPr>
        </p:nvGraphicFramePr>
        <p:xfrm>
          <a:off x="408814" y="5879719"/>
          <a:ext cx="2966378" cy="2212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name="Prism 5" r:id="rId3" imgW="3886200" imgH="2898360" progId="Prism5.Document">
                  <p:embed/>
                </p:oleObj>
              </mc:Choice>
              <mc:Fallback>
                <p:oleObj name="Prism 5" r:id="rId3" imgW="3886200" imgH="28983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8814" y="5879719"/>
                        <a:ext cx="2966378" cy="22126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7" name="Group 46"/>
          <p:cNvGrpSpPr/>
          <p:nvPr/>
        </p:nvGrpSpPr>
        <p:grpSpPr>
          <a:xfrm>
            <a:off x="434710" y="868550"/>
            <a:ext cx="5579030" cy="4303384"/>
            <a:chOff x="434710" y="868550"/>
            <a:chExt cx="5579030" cy="4303384"/>
          </a:xfrm>
        </p:grpSpPr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5"/>
            <a:srcRect l="1276" r="1"/>
            <a:stretch/>
          </p:blipFill>
          <p:spPr>
            <a:xfrm>
              <a:off x="4280746" y="3133886"/>
              <a:ext cx="1718473" cy="1751300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88646" y="1307320"/>
              <a:ext cx="1725094" cy="1735581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7"/>
            <a:srcRect l="1" r="2379"/>
            <a:stretch/>
          </p:blipFill>
          <p:spPr>
            <a:xfrm>
              <a:off x="2459577" y="3133886"/>
              <a:ext cx="1706023" cy="1742303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459577" y="1303934"/>
              <a:ext cx="1703942" cy="1711399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44779" y="1300009"/>
              <a:ext cx="1745330" cy="172340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819206" y="1485048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0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12331" y="1643447"/>
              <a:ext cx="43763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1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409953" y="1446637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2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53110" y="2378994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3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51571" y="4885186"/>
              <a:ext cx="147027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IM-FRET analyzer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434841" y="4918018"/>
              <a:ext cx="147989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CImage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ftware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42459" y="3139856"/>
              <a:ext cx="1745330" cy="1745330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1641335" y="3520155"/>
              <a:ext cx="5629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59.2ps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60419" y="4397803"/>
              <a:ext cx="5629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39.2ps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971749" y="3497151"/>
              <a:ext cx="5629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40.1ps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54038" y="3258296"/>
              <a:ext cx="9338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09.0ps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69255" y="1462782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0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925924" y="3412512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1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979558" y="1431397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2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593368" y="4278121"/>
              <a:ext cx="4492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I 3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34710" y="872456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10426" y="86855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321968" y="2129968"/>
              <a:ext cx="845695" cy="876873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311548" y="3138944"/>
              <a:ext cx="856591" cy="879919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13"/>
            <a:srcRect l="-1" r="328"/>
            <a:stretch/>
          </p:blipFill>
          <p:spPr>
            <a:xfrm>
              <a:off x="4277918" y="2135185"/>
              <a:ext cx="856269" cy="907716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277596" y="3133886"/>
              <a:ext cx="856591" cy="884351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15"/>
            <a:srcRect t="1" r="3970" b="24347"/>
            <a:stretch/>
          </p:blipFill>
          <p:spPr>
            <a:xfrm rot="16200000">
              <a:off x="326053" y="4401446"/>
              <a:ext cx="773504" cy="77532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698168" y="4646219"/>
              <a:ext cx="4876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0ps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81517" y="4021348"/>
              <a:ext cx="4876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7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00ps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55787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4682955"/>
              </p:ext>
            </p:extLst>
          </p:nvPr>
        </p:nvGraphicFramePr>
        <p:xfrm>
          <a:off x="2748416" y="2967264"/>
          <a:ext cx="3287712" cy="2498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0" name="Prism 5" r:id="rId3" imgW="4315680" imgH="3281400" progId="Prism5.Document">
                  <p:embed/>
                </p:oleObj>
              </mc:Choice>
              <mc:Fallback>
                <p:oleObj name="Prism 5" r:id="rId3" imgW="4315680" imgH="3281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48416" y="2967264"/>
                        <a:ext cx="3287712" cy="2498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l="12579" t="14597" r="-1" b="-2"/>
          <a:stretch/>
        </p:blipFill>
        <p:spPr>
          <a:xfrm rot="16200000">
            <a:off x="924187" y="5146516"/>
            <a:ext cx="691126" cy="7698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9629" y="5473757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2500ps</a:t>
            </a:r>
            <a:endParaRPr lang="ko-KR" altLang="en-US" sz="8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917851" y="4653085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3400ps</a:t>
            </a:r>
            <a:endParaRPr lang="ko-KR" altLang="en-US" sz="8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93554" y="4566135"/>
            <a:ext cx="1100468" cy="110758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88611" y="2257921"/>
            <a:ext cx="1106615" cy="110661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308245" y="3399877"/>
            <a:ext cx="449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</a:rPr>
              <a:t>CFP</a:t>
            </a:r>
            <a:endParaRPr lang="ko-KR" altLang="en-US" sz="1200" b="1" dirty="0">
              <a:solidFill>
                <a:schemeClr val="bg1"/>
              </a:solidFill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88611" y="3399878"/>
            <a:ext cx="1101232" cy="110123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339377" y="4282104"/>
            <a:ext cx="837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</a:rPr>
              <a:t>CFP+YFP</a:t>
            </a:r>
            <a:endParaRPr lang="ko-KR" altLang="en-US" sz="1200" b="1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324605" y="5461747"/>
            <a:ext cx="837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</a:rPr>
              <a:t>CFP-YFP</a:t>
            </a:r>
            <a:endParaRPr lang="ko-KR" altLang="en-US" sz="1200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037233" y="22074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003379" y="22074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324606" y="3105207"/>
            <a:ext cx="837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</a:rPr>
              <a:t>CFP</a:t>
            </a:r>
            <a:endParaRPr lang="ko-KR" altLang="en-US" sz="1200" b="1" dirty="0">
              <a:solidFill>
                <a:schemeClr val="bg1"/>
              </a:solidFill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3527457" y="2820206"/>
            <a:ext cx="353943" cy="379070"/>
            <a:chOff x="3945924" y="1966389"/>
            <a:chExt cx="353943" cy="379070"/>
          </a:xfrm>
        </p:grpSpPr>
        <p:sp>
          <p:nvSpPr>
            <p:cNvPr id="19" name="Rounded Rectangle 18"/>
            <p:cNvSpPr/>
            <p:nvPr/>
          </p:nvSpPr>
          <p:spPr>
            <a:xfrm>
              <a:off x="4042898" y="1966389"/>
              <a:ext cx="159997" cy="37907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endParaRPr 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0800000">
              <a:off x="3945924" y="2001006"/>
              <a:ext cx="353943" cy="30713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00" b="1" dirty="0" smtClean="0"/>
                <a:t>CFP</a:t>
              </a:r>
              <a:endParaRPr lang="ko-KR" altLang="en-US" sz="1100" b="1" dirty="0"/>
            </a:p>
          </p:txBody>
        </p:sp>
      </p:grpSp>
      <p:sp>
        <p:nvSpPr>
          <p:cNvPr id="25" name="Rounded Rectangle 24"/>
          <p:cNvSpPr/>
          <p:nvPr/>
        </p:nvSpPr>
        <p:spPr>
          <a:xfrm>
            <a:off x="5101774" y="3830856"/>
            <a:ext cx="159997" cy="37907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7" name="Rounded Rectangle 26"/>
          <p:cNvSpPr/>
          <p:nvPr/>
        </p:nvSpPr>
        <p:spPr>
          <a:xfrm>
            <a:off x="5337421" y="3837556"/>
            <a:ext cx="159997" cy="379070"/>
          </a:xfrm>
          <a:prstGeom prst="roundRect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3" name="TextBox 22"/>
          <p:cNvSpPr txBox="1"/>
          <p:nvPr/>
        </p:nvSpPr>
        <p:spPr>
          <a:xfrm rot="10800000">
            <a:off x="5006910" y="3866823"/>
            <a:ext cx="353943" cy="30713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100" b="1" dirty="0" smtClean="0"/>
              <a:t>CFP</a:t>
            </a:r>
            <a:endParaRPr lang="ko-KR" altLang="en-US" sz="11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233370" y="3875816"/>
            <a:ext cx="353943" cy="30553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100" b="1" dirty="0" smtClean="0"/>
              <a:t>YFP</a:t>
            </a:r>
            <a:endParaRPr lang="ko-KR" altLang="en-US" sz="1100" b="1" dirty="0"/>
          </a:p>
        </p:txBody>
      </p:sp>
      <p:grpSp>
        <p:nvGrpSpPr>
          <p:cNvPr id="28" name="Group 27"/>
          <p:cNvGrpSpPr/>
          <p:nvPr/>
        </p:nvGrpSpPr>
        <p:grpSpPr>
          <a:xfrm>
            <a:off x="4187658" y="2811228"/>
            <a:ext cx="704493" cy="385400"/>
            <a:chOff x="4457080" y="1945814"/>
            <a:chExt cx="704493" cy="385400"/>
          </a:xfrm>
        </p:grpSpPr>
        <p:grpSp>
          <p:nvGrpSpPr>
            <p:cNvPr id="29" name="Group 28"/>
            <p:cNvGrpSpPr/>
            <p:nvPr/>
          </p:nvGrpSpPr>
          <p:grpSpPr>
            <a:xfrm>
              <a:off x="4457080" y="1945814"/>
              <a:ext cx="353943" cy="379070"/>
              <a:chOff x="4493543" y="1945814"/>
              <a:chExt cx="353943" cy="379070"/>
            </a:xfrm>
          </p:grpSpPr>
          <p:sp>
            <p:nvSpPr>
              <p:cNvPr id="34" name="Rounded Rectangle 33"/>
              <p:cNvSpPr/>
              <p:nvPr/>
            </p:nvSpPr>
            <p:spPr>
              <a:xfrm>
                <a:off x="4589908" y="1945814"/>
                <a:ext cx="159997" cy="379070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0800000">
                <a:off x="4493543" y="1990759"/>
                <a:ext cx="353943" cy="307135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ko-KR" sz="1100" b="1" dirty="0" smtClean="0"/>
                  <a:t>CFP</a:t>
                </a:r>
                <a:endParaRPr lang="ko-KR" altLang="en-US" sz="1100" b="1" dirty="0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4807630" y="1952144"/>
              <a:ext cx="353943" cy="379070"/>
              <a:chOff x="4740382" y="1945814"/>
              <a:chExt cx="353943" cy="379070"/>
            </a:xfrm>
          </p:grpSpPr>
          <p:sp>
            <p:nvSpPr>
              <p:cNvPr id="32" name="Rounded Rectangle 31"/>
              <p:cNvSpPr/>
              <p:nvPr/>
            </p:nvSpPr>
            <p:spPr>
              <a:xfrm>
                <a:off x="4835089" y="1945814"/>
                <a:ext cx="159997" cy="379070"/>
              </a:xfrm>
              <a:prstGeom prst="round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0800000">
                <a:off x="4740382" y="1981811"/>
                <a:ext cx="353943" cy="305533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ko-KR" sz="1100" b="1" dirty="0" smtClean="0"/>
                  <a:t>YFP</a:t>
                </a:r>
                <a:endParaRPr lang="ko-KR" altLang="en-US" sz="1100" b="1" dirty="0"/>
              </a:p>
            </p:txBody>
          </p:sp>
        </p:grpSp>
        <p:sp>
          <p:nvSpPr>
            <p:cNvPr id="31" name="TextBox 30"/>
            <p:cNvSpPr txBox="1"/>
            <p:nvPr/>
          </p:nvSpPr>
          <p:spPr>
            <a:xfrm>
              <a:off x="4682803" y="199684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+</a:t>
              </a:r>
              <a:endParaRPr lang="ko-KR" altLang="en-US" sz="1200" b="1" dirty="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0" y="8855905"/>
            <a:ext cx="4443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2.</a:t>
            </a:r>
            <a:endParaRPr lang="en-US" sz="1200" dirty="0"/>
          </a:p>
        </p:txBody>
      </p:sp>
      <p:sp>
        <p:nvSpPr>
          <p:cNvPr id="37" name="Arc 36"/>
          <p:cNvSpPr/>
          <p:nvPr/>
        </p:nvSpPr>
        <p:spPr>
          <a:xfrm>
            <a:off x="5191296" y="3733512"/>
            <a:ext cx="211595" cy="202694"/>
          </a:xfrm>
          <a:prstGeom prst="arc">
            <a:avLst>
              <a:gd name="adj1" fmla="val 10979808"/>
              <a:gd name="adj2" fmla="val 21517205"/>
            </a:avLst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5159107" y="3483774"/>
            <a:ext cx="307777" cy="3536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800" b="1" dirty="0" smtClean="0">
                <a:solidFill>
                  <a:schemeClr val="accent1"/>
                </a:solidFill>
              </a:rPr>
              <a:t>Linker</a:t>
            </a:r>
            <a:endParaRPr lang="ko-KR" altLang="en-US" sz="800" b="1" dirty="0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5955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08</TotalTime>
  <Words>89</Words>
  <Application>Microsoft Office PowerPoint</Application>
  <PresentationFormat>On-screen Show (4:3)</PresentationFormat>
  <Paragraphs>49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Theme</vt:lpstr>
      <vt:lpstr>Prism 5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gis Grailhe(레지스 그레일)</dc:creator>
  <cp:lastModifiedBy>Regis Grailhe</cp:lastModifiedBy>
  <cp:revision>29</cp:revision>
  <cp:lastPrinted>2016-02-03T09:30:44Z</cp:lastPrinted>
  <dcterms:created xsi:type="dcterms:W3CDTF">2015-12-08T00:19:16Z</dcterms:created>
  <dcterms:modified xsi:type="dcterms:W3CDTF">2017-09-18T07:58:38Z</dcterms:modified>
</cp:coreProperties>
</file>